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62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89"/>
    <p:restoredTop sz="94726"/>
  </p:normalViewPr>
  <p:slideViewPr>
    <p:cSldViewPr snapToGrid="0" showGuides="1">
      <p:cViewPr varScale="1">
        <p:scale>
          <a:sx n="90" d="100"/>
          <a:sy n="90" d="100"/>
        </p:scale>
        <p:origin x="4040" y="200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KEDA Daisuke" userId="225571bf-0147-4fe8-adad-fcd4fa2e1a64" providerId="ADAL" clId="{6AB19F94-6CC8-C342-9169-0DE15D563A65}"/>
    <pc:docChg chg="modSld">
      <pc:chgData name="IKEDA Daisuke" userId="225571bf-0147-4fe8-adad-fcd4fa2e1a64" providerId="ADAL" clId="{6AB19F94-6CC8-C342-9169-0DE15D563A65}" dt="2024-08-10T06:51:08.456" v="1" actId="404"/>
      <pc:docMkLst>
        <pc:docMk/>
      </pc:docMkLst>
      <pc:sldChg chg="modSp mod">
        <pc:chgData name="IKEDA Daisuke" userId="225571bf-0147-4fe8-adad-fcd4fa2e1a64" providerId="ADAL" clId="{6AB19F94-6CC8-C342-9169-0DE15D563A65}" dt="2024-08-10T06:51:08.456" v="1" actId="404"/>
        <pc:sldMkLst>
          <pc:docMk/>
          <pc:sldMk cId="1155904318" sldId="627"/>
        </pc:sldMkLst>
        <pc:spChg chg="mod">
          <ac:chgData name="IKEDA Daisuke" userId="225571bf-0147-4fe8-adad-fcd4fa2e1a64" providerId="ADAL" clId="{6AB19F94-6CC8-C342-9169-0DE15D563A65}" dt="2024-08-10T06:51:08.456" v="1" actId="404"/>
          <ac:spMkLst>
            <pc:docMk/>
            <pc:sldMk cId="1155904318" sldId="627"/>
            <ac:spMk id="16" creationId="{4DA48DCD-0720-24E9-2480-6FB81DB08B2B}"/>
          </ac:spMkLst>
        </pc:spChg>
        <pc:spChg chg="mod">
          <ac:chgData name="IKEDA Daisuke" userId="225571bf-0147-4fe8-adad-fcd4fa2e1a64" providerId="ADAL" clId="{6AB19F94-6CC8-C342-9169-0DE15D563A65}" dt="2024-08-10T06:51:08.456" v="1" actId="404"/>
          <ac:spMkLst>
            <pc:docMk/>
            <pc:sldMk cId="1155904318" sldId="627"/>
            <ac:spMk id="27" creationId="{54B33CDD-C1FE-AA01-676B-F711B402F230}"/>
          </ac:spMkLst>
        </pc:spChg>
        <pc:spChg chg="mod">
          <ac:chgData name="IKEDA Daisuke" userId="225571bf-0147-4fe8-adad-fcd4fa2e1a64" providerId="ADAL" clId="{6AB19F94-6CC8-C342-9169-0DE15D563A65}" dt="2024-08-10T06:51:08.456" v="1" actId="404"/>
          <ac:spMkLst>
            <pc:docMk/>
            <pc:sldMk cId="1155904318" sldId="627"/>
            <ac:spMk id="31" creationId="{4F0427E8-AE58-992F-DED1-D98B80E67CE5}"/>
          </ac:spMkLst>
        </pc:spChg>
        <pc:spChg chg="mod">
          <ac:chgData name="IKEDA Daisuke" userId="225571bf-0147-4fe8-adad-fcd4fa2e1a64" providerId="ADAL" clId="{6AB19F94-6CC8-C342-9169-0DE15D563A65}" dt="2024-08-10T06:51:08.456" v="1" actId="404"/>
          <ac:spMkLst>
            <pc:docMk/>
            <pc:sldMk cId="1155904318" sldId="627"/>
            <ac:spMk id="32" creationId="{AE6C7E5C-3C4E-240C-D8EA-229F4465C48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BE89D2-118B-FA48-8E60-76C93D72660B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3B18F9-2814-0C4A-B1EE-C5C6C19D414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3866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3B18F9-2814-0C4A-B1EE-C5C6C19D414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2097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3213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475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0569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735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079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892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6329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22050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092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267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1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4F276-D38D-0F4B-B28E-1AC49BC73D23}" type="datetimeFigureOut">
              <a:rPr kumimoji="1" lang="ja-JP" altLang="en-US" smtClean="0"/>
              <a:t>2024/8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708EC-4059-AC44-BE39-CACC1927C5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304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1B5988EE-284A-A85A-6066-558D66BBDAAD}"/>
              </a:ext>
            </a:extLst>
          </p:cNvPr>
          <p:cNvGrpSpPr/>
          <p:nvPr/>
        </p:nvGrpSpPr>
        <p:grpSpPr>
          <a:xfrm>
            <a:off x="468992" y="872955"/>
            <a:ext cx="5608865" cy="4523593"/>
            <a:chOff x="109764" y="121840"/>
            <a:chExt cx="5608865" cy="4523593"/>
          </a:xfrm>
        </p:grpSpPr>
        <p:pic>
          <p:nvPicPr>
            <p:cNvPr id="25" name="グラフィックス 24">
              <a:extLst>
                <a:ext uri="{FF2B5EF4-FFF2-40B4-BE49-F238E27FC236}">
                  <a16:creationId xmlns:a16="http://schemas.microsoft.com/office/drawing/2014/main" id="{04ACB426-EC42-B8B3-59C7-1CA5602CB1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109764" y="2438400"/>
              <a:ext cx="2489200" cy="2133600"/>
            </a:xfrm>
            <a:prstGeom prst="rect">
              <a:avLst/>
            </a:prstGeom>
          </p:spPr>
        </p:pic>
        <p:pic>
          <p:nvPicPr>
            <p:cNvPr id="17" name="グラフィックス 16">
              <a:extLst>
                <a:ext uri="{FF2B5EF4-FFF2-40B4-BE49-F238E27FC236}">
                  <a16:creationId xmlns:a16="http://schemas.microsoft.com/office/drawing/2014/main" id="{F94D9E8A-9224-EDAF-913B-254AF3D4121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3229429" y="2511833"/>
              <a:ext cx="2489200" cy="2133600"/>
            </a:xfrm>
            <a:prstGeom prst="rect">
              <a:avLst/>
            </a:prstGeom>
          </p:spPr>
        </p:pic>
        <p:pic>
          <p:nvPicPr>
            <p:cNvPr id="8" name="グラフィックス 7">
              <a:extLst>
                <a:ext uri="{FF2B5EF4-FFF2-40B4-BE49-F238E27FC236}">
                  <a16:creationId xmlns:a16="http://schemas.microsoft.com/office/drawing/2014/main" id="{9EB79CA0-6F95-3BC9-DBD8-021051302F6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3229429" y="391497"/>
              <a:ext cx="2489200" cy="2133600"/>
            </a:xfrm>
            <a:prstGeom prst="rect">
              <a:avLst/>
            </a:prstGeom>
          </p:spPr>
        </p:pic>
        <p:pic>
          <p:nvPicPr>
            <p:cNvPr id="19" name="グラフィックス 18">
              <a:extLst>
                <a:ext uri="{FF2B5EF4-FFF2-40B4-BE49-F238E27FC236}">
                  <a16:creationId xmlns:a16="http://schemas.microsoft.com/office/drawing/2014/main" id="{249F6587-D7E5-9C3C-12E1-605AE9909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109764" y="313781"/>
              <a:ext cx="2489200" cy="2133600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54B33CDD-C1FE-AA01-676B-F711B402F230}"/>
                </a:ext>
              </a:extLst>
            </p:cNvPr>
            <p:cNvSpPr txBox="1"/>
            <p:nvPr/>
          </p:nvSpPr>
          <p:spPr>
            <a:xfrm>
              <a:off x="3654566" y="149335"/>
              <a:ext cx="76744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yh7l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4F0427E8-AE58-992F-DED1-D98B80E67CE5}"/>
                </a:ext>
              </a:extLst>
            </p:cNvPr>
            <p:cNvSpPr txBox="1"/>
            <p:nvPr/>
          </p:nvSpPr>
          <p:spPr>
            <a:xfrm>
              <a:off x="3654566" y="2365831"/>
              <a:ext cx="101418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>
                  <a:latin typeface="Arial" panose="020B0604020202020204" pitchFamily="34" charset="0"/>
                  <a:cs typeface="Arial" panose="020B0604020202020204" pitchFamily="34" charset="0"/>
                </a:rPr>
                <a:t>tmod1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AE6C7E5C-3C4E-240C-D8EA-229F4465C489}"/>
                </a:ext>
              </a:extLst>
            </p:cNvPr>
            <p:cNvSpPr txBox="1"/>
            <p:nvPr/>
          </p:nvSpPr>
          <p:spPr>
            <a:xfrm>
              <a:off x="385703" y="121840"/>
              <a:ext cx="99241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usp27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DA48DCD-0720-24E9-2480-6FB81DB08B2B}"/>
                </a:ext>
              </a:extLst>
            </p:cNvPr>
            <p:cNvSpPr txBox="1"/>
            <p:nvPr/>
          </p:nvSpPr>
          <p:spPr>
            <a:xfrm>
              <a:off x="384490" y="2442102"/>
              <a:ext cx="99241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200" err="1">
                  <a:latin typeface="Arial" panose="020B0604020202020204" pitchFamily="34" charset="0"/>
                  <a:cs typeface="Arial" panose="020B0604020202020204" pitchFamily="34" charset="0"/>
                </a:rPr>
                <a:t>mymk</a:t>
              </a:r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1D8759C8-D326-5D64-CCF0-18A680D303CA}"/>
                </a:ext>
              </a:extLst>
            </p:cNvPr>
            <p:cNvCxnSpPr>
              <a:cxnSpLocks/>
            </p:cNvCxnSpPr>
            <p:nvPr/>
          </p:nvCxnSpPr>
          <p:spPr>
            <a:xfrm>
              <a:off x="4304087" y="435739"/>
              <a:ext cx="108208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30620AEF-380E-CBBD-8E48-E98C5E05D194}"/>
                </a:ext>
              </a:extLst>
            </p:cNvPr>
            <p:cNvCxnSpPr>
              <a:cxnSpLocks/>
            </p:cNvCxnSpPr>
            <p:nvPr/>
          </p:nvCxnSpPr>
          <p:spPr>
            <a:xfrm>
              <a:off x="4916431" y="511453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C61C40D2-D85F-988B-CAEB-C53ECE0416B6}"/>
                </a:ext>
              </a:extLst>
            </p:cNvPr>
            <p:cNvCxnSpPr>
              <a:cxnSpLocks/>
            </p:cNvCxnSpPr>
            <p:nvPr/>
          </p:nvCxnSpPr>
          <p:spPr>
            <a:xfrm>
              <a:off x="3879722" y="553094"/>
              <a:ext cx="8603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BA49D592-C8EA-A304-F74B-18CAB06D1F44}"/>
                </a:ext>
              </a:extLst>
            </p:cNvPr>
            <p:cNvCxnSpPr>
              <a:cxnSpLocks/>
            </p:cNvCxnSpPr>
            <p:nvPr/>
          </p:nvCxnSpPr>
          <p:spPr>
            <a:xfrm>
              <a:off x="3879722" y="646280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E3DAF2EB-380E-80F7-5F94-BB14FF6FA9FE}"/>
                </a:ext>
              </a:extLst>
            </p:cNvPr>
            <p:cNvSpPr txBox="1"/>
            <p:nvPr/>
          </p:nvSpPr>
          <p:spPr>
            <a:xfrm>
              <a:off x="4757153" y="323312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D29FDFC0-5FD2-326C-9EDF-7C4801DBF351}"/>
                </a:ext>
              </a:extLst>
            </p:cNvPr>
            <p:cNvSpPr txBox="1"/>
            <p:nvPr/>
          </p:nvSpPr>
          <p:spPr>
            <a:xfrm>
              <a:off x="4990121" y="393203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D08EE81F-F651-9FA3-4A8B-B07654F06D62}"/>
                </a:ext>
              </a:extLst>
            </p:cNvPr>
            <p:cNvSpPr txBox="1"/>
            <p:nvPr/>
          </p:nvSpPr>
          <p:spPr>
            <a:xfrm>
              <a:off x="4192204" y="422223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3AD5DC36-0741-1A52-DD1D-971818A15E78}"/>
                </a:ext>
              </a:extLst>
            </p:cNvPr>
            <p:cNvSpPr txBox="1"/>
            <p:nvPr/>
          </p:nvSpPr>
          <p:spPr>
            <a:xfrm>
              <a:off x="3976708" y="521234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cxnSp>
          <p:nvCxnSpPr>
            <p:cNvPr id="62" name="直線コネクタ 61">
              <a:extLst>
                <a:ext uri="{FF2B5EF4-FFF2-40B4-BE49-F238E27FC236}">
                  <a16:creationId xmlns:a16="http://schemas.microsoft.com/office/drawing/2014/main" id="{626E9EAC-D16E-E8F0-734D-96180AE293DB}"/>
                </a:ext>
              </a:extLst>
            </p:cNvPr>
            <p:cNvCxnSpPr>
              <a:cxnSpLocks/>
            </p:cNvCxnSpPr>
            <p:nvPr/>
          </p:nvCxnSpPr>
          <p:spPr>
            <a:xfrm>
              <a:off x="3843975" y="2777069"/>
              <a:ext cx="15654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:a16="http://schemas.microsoft.com/office/drawing/2014/main" id="{7598D9CD-4676-9999-19B3-2F14E81D0751}"/>
                </a:ext>
              </a:extLst>
            </p:cNvPr>
            <p:cNvCxnSpPr>
              <a:cxnSpLocks/>
            </p:cNvCxnSpPr>
            <p:nvPr/>
          </p:nvCxnSpPr>
          <p:spPr>
            <a:xfrm>
              <a:off x="4327384" y="2846960"/>
              <a:ext cx="108208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:a16="http://schemas.microsoft.com/office/drawing/2014/main" id="{99F1E71F-70BE-30F2-0561-56A8A6281C7E}"/>
                </a:ext>
              </a:extLst>
            </p:cNvPr>
            <p:cNvCxnSpPr>
              <a:cxnSpLocks/>
            </p:cNvCxnSpPr>
            <p:nvPr/>
          </p:nvCxnSpPr>
          <p:spPr>
            <a:xfrm>
              <a:off x="4939728" y="2922674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C66F8DDE-D512-20B2-0A32-6EC95DEB2B3D}"/>
                </a:ext>
              </a:extLst>
            </p:cNvPr>
            <p:cNvCxnSpPr>
              <a:cxnSpLocks/>
            </p:cNvCxnSpPr>
            <p:nvPr/>
          </p:nvCxnSpPr>
          <p:spPr>
            <a:xfrm>
              <a:off x="3891371" y="3230067"/>
              <a:ext cx="8603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3FBD378A-06C6-0694-8A0E-F447C7EA67E0}"/>
                </a:ext>
              </a:extLst>
            </p:cNvPr>
            <p:cNvCxnSpPr>
              <a:cxnSpLocks/>
            </p:cNvCxnSpPr>
            <p:nvPr/>
          </p:nvCxnSpPr>
          <p:spPr>
            <a:xfrm>
              <a:off x="3891371" y="3323253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50B66E96-037F-53D1-AD88-EFBEE711302B}"/>
                </a:ext>
              </a:extLst>
            </p:cNvPr>
            <p:cNvSpPr txBox="1"/>
            <p:nvPr/>
          </p:nvSpPr>
          <p:spPr>
            <a:xfrm>
              <a:off x="4547482" y="2635522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</a:t>
              </a:r>
              <a:endParaRPr lang="ja-JP" altLang="en-US" sz="700"/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B94008D6-5441-9230-B5F2-85D94FA44BC0}"/>
                </a:ext>
              </a:extLst>
            </p:cNvPr>
            <p:cNvSpPr txBox="1"/>
            <p:nvPr/>
          </p:nvSpPr>
          <p:spPr>
            <a:xfrm>
              <a:off x="4780450" y="2734533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23D2CA65-23C9-C456-84EB-66A1BBF6A588}"/>
                </a:ext>
              </a:extLst>
            </p:cNvPr>
            <p:cNvSpPr txBox="1"/>
            <p:nvPr/>
          </p:nvSpPr>
          <p:spPr>
            <a:xfrm>
              <a:off x="5013418" y="2804424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88037661-1370-250B-1227-58EB32AFE928}"/>
                </a:ext>
              </a:extLst>
            </p:cNvPr>
            <p:cNvSpPr txBox="1"/>
            <p:nvPr/>
          </p:nvSpPr>
          <p:spPr>
            <a:xfrm>
              <a:off x="4203853" y="3099196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3320B2FB-B91C-38AA-05D1-E3EF6E6B1066}"/>
                </a:ext>
              </a:extLst>
            </p:cNvPr>
            <p:cNvSpPr txBox="1"/>
            <p:nvPr/>
          </p:nvSpPr>
          <p:spPr>
            <a:xfrm>
              <a:off x="3988357" y="3198207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id="{2044A8A9-3956-63A0-DD39-4FB4CE1D86F9}"/>
                </a:ext>
              </a:extLst>
            </p:cNvPr>
            <p:cNvCxnSpPr>
              <a:cxnSpLocks/>
            </p:cNvCxnSpPr>
            <p:nvPr/>
          </p:nvCxnSpPr>
          <p:spPr>
            <a:xfrm>
              <a:off x="1182314" y="447483"/>
              <a:ext cx="108208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線コネクタ 73">
              <a:extLst>
                <a:ext uri="{FF2B5EF4-FFF2-40B4-BE49-F238E27FC236}">
                  <a16:creationId xmlns:a16="http://schemas.microsoft.com/office/drawing/2014/main" id="{AF2C7A29-BDF9-28FE-0320-E9974C0B8B57}"/>
                </a:ext>
              </a:extLst>
            </p:cNvPr>
            <p:cNvCxnSpPr>
              <a:cxnSpLocks/>
            </p:cNvCxnSpPr>
            <p:nvPr/>
          </p:nvCxnSpPr>
          <p:spPr>
            <a:xfrm>
              <a:off x="1794658" y="523197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F6B9B3EF-F973-0A5C-E0C6-6997D188B523}"/>
                </a:ext>
              </a:extLst>
            </p:cNvPr>
            <p:cNvCxnSpPr>
              <a:cxnSpLocks/>
            </p:cNvCxnSpPr>
            <p:nvPr/>
          </p:nvCxnSpPr>
          <p:spPr>
            <a:xfrm>
              <a:off x="757949" y="564838"/>
              <a:ext cx="8603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51EDEA0F-3977-567D-F5C7-FEDB06FE0D5B}"/>
                </a:ext>
              </a:extLst>
            </p:cNvPr>
            <p:cNvCxnSpPr>
              <a:cxnSpLocks/>
            </p:cNvCxnSpPr>
            <p:nvPr/>
          </p:nvCxnSpPr>
          <p:spPr>
            <a:xfrm>
              <a:off x="757949" y="658024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79D5738F-1568-8872-CBE9-A8380B4E4303}"/>
                </a:ext>
              </a:extLst>
            </p:cNvPr>
            <p:cNvSpPr txBox="1"/>
            <p:nvPr/>
          </p:nvSpPr>
          <p:spPr>
            <a:xfrm>
              <a:off x="1635380" y="335056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A2FA8FFD-C862-B545-B129-8A10908B1134}"/>
                </a:ext>
              </a:extLst>
            </p:cNvPr>
            <p:cNvSpPr txBox="1"/>
            <p:nvPr/>
          </p:nvSpPr>
          <p:spPr>
            <a:xfrm>
              <a:off x="1868348" y="404947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7260A530-A9DC-E24B-E42B-FE1959203C1F}"/>
                </a:ext>
              </a:extLst>
            </p:cNvPr>
            <p:cNvSpPr txBox="1"/>
            <p:nvPr/>
          </p:nvSpPr>
          <p:spPr>
            <a:xfrm>
              <a:off x="1070431" y="433967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CF929271-88A1-C73A-465A-4BCCDD3B8D64}"/>
                </a:ext>
              </a:extLst>
            </p:cNvPr>
            <p:cNvSpPr txBox="1"/>
            <p:nvPr/>
          </p:nvSpPr>
          <p:spPr>
            <a:xfrm>
              <a:off x="854935" y="532978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6012C58B-8927-7B96-A99A-C6CD8E6D0299}"/>
                </a:ext>
              </a:extLst>
            </p:cNvPr>
            <p:cNvCxnSpPr>
              <a:cxnSpLocks/>
            </p:cNvCxnSpPr>
            <p:nvPr/>
          </p:nvCxnSpPr>
          <p:spPr>
            <a:xfrm>
              <a:off x="728026" y="2410241"/>
              <a:ext cx="156548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17057080-22A6-2F84-DED0-A02F8BBE8976}"/>
                </a:ext>
              </a:extLst>
            </p:cNvPr>
            <p:cNvCxnSpPr>
              <a:cxnSpLocks/>
            </p:cNvCxnSpPr>
            <p:nvPr/>
          </p:nvCxnSpPr>
          <p:spPr>
            <a:xfrm>
              <a:off x="1211435" y="2480132"/>
              <a:ext cx="108208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線コネクタ 82">
              <a:extLst>
                <a:ext uri="{FF2B5EF4-FFF2-40B4-BE49-F238E27FC236}">
                  <a16:creationId xmlns:a16="http://schemas.microsoft.com/office/drawing/2014/main" id="{9566481E-4390-A0C5-B2FA-6D94CC2FD983}"/>
                </a:ext>
              </a:extLst>
            </p:cNvPr>
            <p:cNvCxnSpPr>
              <a:cxnSpLocks/>
            </p:cNvCxnSpPr>
            <p:nvPr/>
          </p:nvCxnSpPr>
          <p:spPr>
            <a:xfrm>
              <a:off x="1823779" y="2555846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C7AACF83-5016-365A-3F4A-BD37C753800D}"/>
                </a:ext>
              </a:extLst>
            </p:cNvPr>
            <p:cNvCxnSpPr>
              <a:cxnSpLocks/>
            </p:cNvCxnSpPr>
            <p:nvPr/>
          </p:nvCxnSpPr>
          <p:spPr>
            <a:xfrm>
              <a:off x="734654" y="3366381"/>
              <a:ext cx="8603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>
              <a:extLst>
                <a:ext uri="{FF2B5EF4-FFF2-40B4-BE49-F238E27FC236}">
                  <a16:creationId xmlns:a16="http://schemas.microsoft.com/office/drawing/2014/main" id="{23A8E3E0-4420-4A23-67D9-763EFADD1831}"/>
                </a:ext>
              </a:extLst>
            </p:cNvPr>
            <p:cNvCxnSpPr>
              <a:cxnSpLocks/>
            </p:cNvCxnSpPr>
            <p:nvPr/>
          </p:nvCxnSpPr>
          <p:spPr>
            <a:xfrm>
              <a:off x="734654" y="3459567"/>
              <a:ext cx="4697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35F6C3E1-78AC-F5D4-4014-D777579989CA}"/>
                </a:ext>
              </a:extLst>
            </p:cNvPr>
            <p:cNvSpPr txBox="1"/>
            <p:nvPr/>
          </p:nvSpPr>
          <p:spPr>
            <a:xfrm>
              <a:off x="1431533" y="2268694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3C9FAAE9-D2A3-AD9C-3854-8B9AC0B4C66B}"/>
                </a:ext>
              </a:extLst>
            </p:cNvPr>
            <p:cNvSpPr txBox="1"/>
            <p:nvPr/>
          </p:nvSpPr>
          <p:spPr>
            <a:xfrm>
              <a:off x="1664501" y="2367705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128E9AF4-3ECB-5A0D-0693-41FB42FFCD37}"/>
                </a:ext>
              </a:extLst>
            </p:cNvPr>
            <p:cNvSpPr txBox="1"/>
            <p:nvPr/>
          </p:nvSpPr>
          <p:spPr>
            <a:xfrm>
              <a:off x="1897469" y="2437596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015E98C8-2EBB-3F08-1321-E5725A6163CF}"/>
                </a:ext>
              </a:extLst>
            </p:cNvPr>
            <p:cNvSpPr txBox="1"/>
            <p:nvPr/>
          </p:nvSpPr>
          <p:spPr>
            <a:xfrm>
              <a:off x="1047136" y="3235510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38162F0C-1D0D-E4C3-4A40-4519E4D880F0}"/>
                </a:ext>
              </a:extLst>
            </p:cNvPr>
            <p:cNvSpPr txBox="1"/>
            <p:nvPr/>
          </p:nvSpPr>
          <p:spPr>
            <a:xfrm>
              <a:off x="831640" y="3334521"/>
              <a:ext cx="466745" cy="20005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700"/>
                <a:t>***</a:t>
              </a:r>
              <a:endParaRPr lang="ja-JP" altLang="en-US" sz="700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993D5B1-905B-5C6C-EB13-9D1B5F69A695}"/>
              </a:ext>
            </a:extLst>
          </p:cNvPr>
          <p:cNvSpPr txBox="1"/>
          <p:nvPr/>
        </p:nvSpPr>
        <p:spPr>
          <a:xfrm>
            <a:off x="309783" y="5463832"/>
            <a:ext cx="62384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Comparison of myocyte marker gene expression levels in primary cultured myoblasts and JEM1129. The expression levels are presented as means ± standard deviations (n=6). In the post-hoc test, asterisks indicate statistical significance in comparisons between different conditions (**: p &lt; 0.01, ***: p &lt; 0.001). 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904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095</TotalTime>
  <Words>79</Words>
  <Application>Microsoft Macintosh PowerPoint</Application>
  <PresentationFormat>レター サイズ 8.5x11 インチ</PresentationFormat>
  <Paragraphs>2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KEDA Daisuke</dc:creator>
  <cp:lastModifiedBy>IKEDA Daisuke</cp:lastModifiedBy>
  <cp:revision>3</cp:revision>
  <cp:lastPrinted>2024-08-07T09:54:35Z</cp:lastPrinted>
  <dcterms:created xsi:type="dcterms:W3CDTF">2024-01-12T09:46:10Z</dcterms:created>
  <dcterms:modified xsi:type="dcterms:W3CDTF">2024-08-10T06:51:12Z</dcterms:modified>
</cp:coreProperties>
</file>